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5328F0-56EA-4551-B8CE-3A7F54325A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311F7D-BA10-45CA-85BA-9568BF2A1C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D75BAA-800B-483B-B5DD-804FFBB352B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0CFCD9-72B2-4AA7-B0E5-C374453E5E5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B70376-6986-4859-AF78-58F8BC2988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644141-44BC-4C19-BC91-297300B15F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997CAF-3374-4021-BCDD-86B8241E74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7ADB00-849A-4D7C-9717-5A040FE45D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5CF554-B195-4720-BEEB-D2BEF168FB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F5AD90-72A1-496A-BAB5-AA2D30DE62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85DD42-E860-433B-A694-CA58BE7822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89433F-95DD-49F6-B8F1-DB782A802B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BA5224-680A-478D-A6F3-35E6A61DB7D3}" type="slidenum">
              <a:rPr b="0" lang="es-MX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09"/>
          <p:cNvSpPr/>
          <p:nvPr/>
        </p:nvSpPr>
        <p:spPr>
          <a:xfrm>
            <a:off x="257040" y="6095880"/>
            <a:ext cx="6228000" cy="162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 | Impaired lymphoid differentiation support from ALL mesenchymal stromal cells (MSC)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ematopoietic stem and progenitor cells (HSPC) from NBM were co-cultured with NBM-MSC or ALL-MSC monolayers in lymphoid conditions during 4 weeks. Flow cytometry analyses of the newly produced cells and recorded yields per input of B cells are shown (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NBM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3, 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ALL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4)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 VLA-4 expression on normal or ALL MNC (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NBM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4, 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ALL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4)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and VCAM-I expression on normal or ALL MSC (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NBM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3, 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ALL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5)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were evaluated, suggesting an impaired VLA-4/VCAM-1 axis in ALL. NBM: Normal Bone Marrow; ALL: Acute Lymphoblastic Leukemia; Mononuclear Cells (MNC).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72 Grupo"/>
          <p:cNvGrpSpPr/>
          <p:nvPr/>
        </p:nvGrpSpPr>
        <p:grpSpPr>
          <a:xfrm>
            <a:off x="784080" y="399960"/>
            <a:ext cx="5300280" cy="5516280"/>
            <a:chOff x="784080" y="399960"/>
            <a:chExt cx="5300280" cy="5516280"/>
          </a:xfrm>
        </p:grpSpPr>
        <p:sp>
          <p:nvSpPr>
            <p:cNvPr id="43" name="CuadroTexto 1"/>
            <p:cNvSpPr/>
            <p:nvPr/>
          </p:nvSpPr>
          <p:spPr>
            <a:xfrm>
              <a:off x="840960" y="2585160"/>
              <a:ext cx="38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Times New Roman"/>
                  <a:ea typeface="MS PGothic"/>
                </a:rPr>
                <a:t>(B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CuadroTexto 42"/>
            <p:cNvSpPr/>
            <p:nvPr/>
          </p:nvSpPr>
          <p:spPr>
            <a:xfrm>
              <a:off x="852840" y="4294080"/>
              <a:ext cx="391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000000"/>
                  </a:solidFill>
                  <a:latin typeface="Times New Roman"/>
                  <a:ea typeface="MS PGothic"/>
                </a:rPr>
                <a:t>(</a:t>
              </a:r>
              <a:r>
                <a:rPr b="1" lang="es-ES" sz="1200" spc="-1" strike="noStrike">
                  <a:solidFill>
                    <a:srgbClr val="000000"/>
                  </a:solidFill>
                  <a:latin typeface="Times New Roman"/>
                  <a:ea typeface="MS PGothic"/>
                </a:rPr>
                <a:t>C</a:t>
              </a:r>
              <a:r>
                <a:rPr b="0" lang="es-ES" sz="1200" spc="-1" strike="noStrike">
                  <a:solidFill>
                    <a:srgbClr val="000000"/>
                  </a:solidFill>
                  <a:latin typeface="Times New Roman"/>
                  <a:ea typeface="MS PGothic"/>
                </a:rPr>
                <a:t>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TextBox 86"/>
            <p:cNvSpPr/>
            <p:nvPr/>
          </p:nvSpPr>
          <p:spPr>
            <a:xfrm>
              <a:off x="784080" y="439920"/>
              <a:ext cx="576720" cy="365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182880" rIns="182880" tIns="91440" bIns="9144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MS PGothic"/>
                </a:rPr>
                <a:t>(A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6" name="71 Grupo"/>
            <p:cNvGrpSpPr/>
            <p:nvPr/>
          </p:nvGrpSpPr>
          <p:grpSpPr>
            <a:xfrm>
              <a:off x="959760" y="399960"/>
              <a:ext cx="5124600" cy="2197080"/>
              <a:chOff x="959760" y="399960"/>
              <a:chExt cx="5124600" cy="2197080"/>
            </a:xfrm>
          </p:grpSpPr>
          <p:pic>
            <p:nvPicPr>
              <p:cNvPr id="47" name="Picture 85" descr=""/>
              <p:cNvPicPr/>
              <p:nvPr/>
            </p:nvPicPr>
            <p:blipFill>
              <a:blip r:embed="rId1"/>
              <a:srcRect l="15189" t="0" r="20412" b="21738"/>
              <a:stretch/>
            </p:blipFill>
            <p:spPr>
              <a:xfrm>
                <a:off x="4519800" y="856440"/>
                <a:ext cx="1503360" cy="137484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48" name="Group 88"/>
              <p:cNvGrpSpPr/>
              <p:nvPr/>
            </p:nvGrpSpPr>
            <p:grpSpPr>
              <a:xfrm>
                <a:off x="1189080" y="776160"/>
                <a:ext cx="4150440" cy="1672920"/>
                <a:chOff x="1189080" y="776160"/>
                <a:chExt cx="4150440" cy="1672920"/>
              </a:xfrm>
            </p:grpSpPr>
            <p:pic>
              <p:nvPicPr>
                <p:cNvPr id="49" name="Picture 89" descr=""/>
                <p:cNvPicPr/>
                <p:nvPr/>
              </p:nvPicPr>
              <p:blipFill>
                <a:blip r:embed="rId2"/>
                <a:srcRect l="8079" t="0" r="0" b="26033"/>
                <a:stretch/>
              </p:blipFill>
              <p:spPr>
                <a:xfrm>
                  <a:off x="1189080" y="776160"/>
                  <a:ext cx="1531080" cy="15418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0" name="Picture 90" descr=""/>
                <p:cNvPicPr/>
                <p:nvPr/>
              </p:nvPicPr>
              <p:blipFill>
                <a:blip r:embed="rId3"/>
                <a:srcRect l="8911" t="0" r="0" b="26116"/>
                <a:stretch/>
              </p:blipFill>
              <p:spPr>
                <a:xfrm>
                  <a:off x="2733120" y="780120"/>
                  <a:ext cx="1523520" cy="15462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1" name="CuadroTexto 12"/>
                <p:cNvSpPr/>
                <p:nvPr/>
              </p:nvSpPr>
              <p:spPr>
                <a:xfrm>
                  <a:off x="1330920" y="797040"/>
                  <a:ext cx="447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MS PGothic"/>
                    </a:rPr>
                    <a:t>14.9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" name="CuadroTexto 12"/>
                <p:cNvSpPr/>
                <p:nvPr/>
              </p:nvSpPr>
              <p:spPr>
                <a:xfrm>
                  <a:off x="2327760" y="800640"/>
                  <a:ext cx="447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MS PGothic"/>
                    </a:rPr>
                    <a:t>0.66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" name="CuadroTexto 12"/>
                <p:cNvSpPr/>
                <p:nvPr/>
              </p:nvSpPr>
              <p:spPr>
                <a:xfrm>
                  <a:off x="2321280" y="1926000"/>
                  <a:ext cx="447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MS PGothic"/>
                    </a:rPr>
                    <a:t>29.4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" name="CuadroTexto 12"/>
                <p:cNvSpPr/>
                <p:nvPr/>
              </p:nvSpPr>
              <p:spPr>
                <a:xfrm>
                  <a:off x="1346040" y="1928160"/>
                  <a:ext cx="447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MS PGothic"/>
                    </a:rPr>
                    <a:t>55.1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5" name="CuadroTexto 12"/>
                <p:cNvSpPr/>
                <p:nvPr/>
              </p:nvSpPr>
              <p:spPr>
                <a:xfrm>
                  <a:off x="4811400" y="2172600"/>
                  <a:ext cx="5281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MS PGothic"/>
                    </a:rPr>
                    <a:t>NBM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" name="CuadroTexto 12"/>
                <p:cNvSpPr/>
                <p:nvPr/>
              </p:nvSpPr>
              <p:spPr>
                <a:xfrm>
                  <a:off x="3864240" y="801720"/>
                  <a:ext cx="447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MS PGothic"/>
                    </a:rPr>
                    <a:t>0.39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" name="CuadroTexto 12"/>
                <p:cNvSpPr/>
                <p:nvPr/>
              </p:nvSpPr>
              <p:spPr>
                <a:xfrm>
                  <a:off x="3864240" y="1921680"/>
                  <a:ext cx="447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MS PGothic"/>
                    </a:rPr>
                    <a:t>2.59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" name="CuadroTexto 12"/>
                <p:cNvSpPr/>
                <p:nvPr/>
              </p:nvSpPr>
              <p:spPr>
                <a:xfrm>
                  <a:off x="2881080" y="1926000"/>
                  <a:ext cx="4474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1200" spc="-1" strike="noStrike">
                      <a:solidFill>
                        <a:srgbClr val="000000"/>
                      </a:solidFill>
                      <a:latin typeface="Times New Roman"/>
                      <a:ea typeface="MS PGothic"/>
                    </a:rPr>
                    <a:t>85.2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59" name="CuadroTexto 12"/>
              <p:cNvSpPr/>
              <p:nvPr/>
            </p:nvSpPr>
            <p:spPr>
              <a:xfrm>
                <a:off x="5422320" y="2147400"/>
                <a:ext cx="662040" cy="365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  <a:ea typeface="MS PGothic"/>
                  </a:rPr>
                  <a:t>ALL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60" name="Conector recto de flecha 13"/>
              <p:cNvCxnSpPr/>
              <p:nvPr/>
            </p:nvCxnSpPr>
            <p:spPr>
              <a:xfrm>
                <a:off x="1144440" y="2387880"/>
                <a:ext cx="2639880" cy="8640"/>
              </a:xfrm>
              <a:prstGeom prst="straightConnector1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</p:cxnSp>
          <p:cxnSp>
            <p:nvCxnSpPr>
              <p:cNvPr id="61" name="Conector recto de flecha 14"/>
              <p:cNvCxnSpPr/>
              <p:nvPr/>
            </p:nvCxnSpPr>
            <p:spPr>
              <a:xfrm flipV="1">
                <a:off x="1153800" y="1346040"/>
                <a:ext cx="1080" cy="1033200"/>
              </a:xfrm>
              <a:prstGeom prst="straightConnector1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</p:cxnSp>
          <p:sp>
            <p:nvSpPr>
              <p:cNvPr id="62" name="CuadroTexto 15"/>
              <p:cNvSpPr/>
              <p:nvPr/>
            </p:nvSpPr>
            <p:spPr>
              <a:xfrm rot="16200000">
                <a:off x="777240" y="869760"/>
                <a:ext cx="730800" cy="365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  <a:ea typeface="MS PGothic"/>
                  </a:rPr>
                  <a:t>CD56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CuadroTexto 15"/>
              <p:cNvSpPr/>
              <p:nvPr/>
            </p:nvSpPr>
            <p:spPr>
              <a:xfrm>
                <a:off x="3786480" y="2231280"/>
                <a:ext cx="730800" cy="365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  <a:ea typeface="MS PGothic"/>
                  </a:rPr>
                  <a:t>CD19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CuadroTexto 15"/>
              <p:cNvSpPr/>
              <p:nvPr/>
            </p:nvSpPr>
            <p:spPr>
              <a:xfrm rot="16200000">
                <a:off x="3798360" y="1313280"/>
                <a:ext cx="1288440" cy="365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82880" rIns="182880" tIns="91440" bIns="9144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  <a:ea typeface="MS PGothic"/>
                  </a:rPr>
                  <a:t>Yield per input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CuadroTexto 27"/>
              <p:cNvSpPr/>
              <p:nvPr/>
            </p:nvSpPr>
            <p:spPr>
              <a:xfrm>
                <a:off x="5423040" y="1847160"/>
                <a:ext cx="534240" cy="2156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s-ES" sz="800" spc="-1" strike="noStrike">
                    <a:solidFill>
                      <a:srgbClr val="000000"/>
                    </a:solidFill>
                    <a:latin typeface="Times New Roman"/>
                    <a:ea typeface="MS PGothic"/>
                  </a:rPr>
                  <a:t>p=0.02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CuadroTexto 27"/>
              <p:cNvSpPr/>
              <p:nvPr/>
            </p:nvSpPr>
            <p:spPr>
              <a:xfrm>
                <a:off x="5565600" y="1973160"/>
                <a:ext cx="232560" cy="154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b">
                <a:spAutoFit/>
              </a:bodyPr>
              <a:p>
                <a:pPr>
                  <a:lnSpc>
                    <a:spcPct val="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800" spc="-1" strike="noStrike">
                    <a:solidFill>
                      <a:srgbClr val="000000"/>
                    </a:solidFill>
                    <a:latin typeface="Times New Roman"/>
                    <a:ea typeface="MS PGothic"/>
                  </a:rPr>
                  <a:t>*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" name="CuadroTexto 10"/>
              <p:cNvSpPr/>
              <p:nvPr/>
            </p:nvSpPr>
            <p:spPr>
              <a:xfrm>
                <a:off x="1557360" y="402480"/>
                <a:ext cx="94284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  <a:ea typeface="MS PGothic"/>
                  </a:rPr>
                  <a:t>NBM-CD34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  <a:ea typeface="MS PGothic"/>
                  </a:rPr>
                  <a:t>NBM MSC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CuadroTexto 10"/>
              <p:cNvSpPr/>
              <p:nvPr/>
            </p:nvSpPr>
            <p:spPr>
              <a:xfrm>
                <a:off x="3114720" y="399960"/>
                <a:ext cx="94284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  <a:ea typeface="MS PGothic"/>
                  </a:rPr>
                  <a:t>NBM-CD34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  <a:ea typeface="MS PGothic"/>
                  </a:rPr>
                  <a:t>ALL MSC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9" name="70 Grupo"/>
            <p:cNvGrpSpPr/>
            <p:nvPr/>
          </p:nvGrpSpPr>
          <p:grpSpPr>
            <a:xfrm>
              <a:off x="1139040" y="2659680"/>
              <a:ext cx="3867480" cy="1662480"/>
              <a:chOff x="1139040" y="2659680"/>
              <a:chExt cx="3867480" cy="1662480"/>
            </a:xfrm>
          </p:grpSpPr>
          <p:pic>
            <p:nvPicPr>
              <p:cNvPr id="70" name="Picture 15" descr=""/>
              <p:cNvPicPr/>
              <p:nvPr/>
            </p:nvPicPr>
            <p:blipFill>
              <a:blip r:embed="rId4"/>
              <a:srcRect l="13433" t="6202" r="3245" b="31161"/>
              <a:stretch/>
            </p:blipFill>
            <p:spPr>
              <a:xfrm>
                <a:off x="1353240" y="2932200"/>
                <a:ext cx="1158120" cy="11404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1" name="Picture 16" descr=""/>
              <p:cNvPicPr/>
              <p:nvPr/>
            </p:nvPicPr>
            <p:blipFill>
              <a:blip r:embed="rId5"/>
              <a:srcRect l="11985" t="5473" r="0" b="30863"/>
              <a:stretch/>
            </p:blipFill>
            <p:spPr>
              <a:xfrm>
                <a:off x="3770640" y="2938680"/>
                <a:ext cx="1235880" cy="1171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72" name="Picture 14" descr=""/>
              <p:cNvPicPr/>
              <p:nvPr/>
            </p:nvPicPr>
            <p:blipFill>
              <a:blip r:embed="rId6"/>
              <a:srcRect l="10506" t="5920" r="4509" b="30879"/>
              <a:stretch/>
            </p:blipFill>
            <p:spPr>
              <a:xfrm>
                <a:off x="2531160" y="2932200"/>
                <a:ext cx="1202040" cy="1171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3" name="CuadroTexto 10"/>
              <p:cNvSpPr/>
              <p:nvPr/>
            </p:nvSpPr>
            <p:spPr>
              <a:xfrm>
                <a:off x="1525680" y="2659680"/>
                <a:ext cx="925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  <a:ea typeface="MS PGothic"/>
                  </a:rPr>
                  <a:t>NBM-MNC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" name="CuadroTexto 11"/>
              <p:cNvSpPr/>
              <p:nvPr/>
            </p:nvSpPr>
            <p:spPr>
              <a:xfrm>
                <a:off x="3391920" y="2659680"/>
                <a:ext cx="874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  <a:ea typeface="MS PGothic"/>
                  </a:rPr>
                  <a:t>ALL-MNC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" name="CuadroTexto 12"/>
              <p:cNvSpPr/>
              <p:nvPr/>
            </p:nvSpPr>
            <p:spPr>
              <a:xfrm>
                <a:off x="4374720" y="4045680"/>
                <a:ext cx="619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  <a:ea typeface="MS PGothic"/>
                  </a:rPr>
                  <a:t>VLA-4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76" name="Conector recto de flecha 13"/>
              <p:cNvCxnSpPr/>
              <p:nvPr/>
            </p:nvCxnSpPr>
            <p:spPr>
              <a:xfrm>
                <a:off x="1536120" y="4160880"/>
                <a:ext cx="2765160" cy="1080"/>
              </a:xfrm>
              <a:prstGeom prst="straightConnector1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</p:cxnSp>
          <p:sp>
            <p:nvSpPr>
              <p:cNvPr id="77" name="CuadroTexto 15"/>
              <p:cNvSpPr/>
              <p:nvPr/>
            </p:nvSpPr>
            <p:spPr>
              <a:xfrm rot="16200000">
                <a:off x="1004760" y="3031560"/>
                <a:ext cx="545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  <a:ea typeface="MS PGothic"/>
                  </a:rPr>
                  <a:t>CD34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78" name="66 Conector recto de flecha"/>
              <p:cNvCxnSpPr/>
              <p:nvPr/>
            </p:nvCxnSpPr>
            <p:spPr>
              <a:xfrm flipV="1">
                <a:off x="1266120" y="3452400"/>
                <a:ext cx="1080" cy="372600"/>
              </a:xfrm>
              <a:prstGeom prst="straightConnector1">
                <a:avLst/>
              </a:prstGeom>
              <a:ln w="25560">
                <a:solidFill>
                  <a:srgbClr val="000000"/>
                </a:solidFill>
                <a:miter/>
                <a:tailEnd len="med" type="arrow" w="med"/>
              </a:ln>
            </p:spPr>
          </p:cxnSp>
        </p:grpSp>
        <p:grpSp>
          <p:nvGrpSpPr>
            <p:cNvPr id="79" name="69 Grupo"/>
            <p:cNvGrpSpPr/>
            <p:nvPr/>
          </p:nvGrpSpPr>
          <p:grpSpPr>
            <a:xfrm>
              <a:off x="1158840" y="4317480"/>
              <a:ext cx="3898080" cy="1598760"/>
              <a:chOff x="1158840" y="4317480"/>
              <a:chExt cx="3898080" cy="1598760"/>
            </a:xfrm>
          </p:grpSpPr>
          <p:pic>
            <p:nvPicPr>
              <p:cNvPr id="80" name="Picture 5" descr=""/>
              <p:cNvPicPr/>
              <p:nvPr/>
            </p:nvPicPr>
            <p:blipFill>
              <a:blip r:embed="rId7"/>
              <a:srcRect l="6501" t="6751" r="4447" b="31514"/>
              <a:stretch/>
            </p:blipFill>
            <p:spPr>
              <a:xfrm>
                <a:off x="2526120" y="4593960"/>
                <a:ext cx="1225440" cy="1070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1" name="Picture 3" descr=""/>
              <p:cNvPicPr/>
              <p:nvPr/>
            </p:nvPicPr>
            <p:blipFill>
              <a:blip r:embed="rId8"/>
              <a:srcRect l="11667" t="6030" r="4437" b="29891"/>
              <a:stretch/>
            </p:blipFill>
            <p:spPr>
              <a:xfrm>
                <a:off x="1391760" y="4559040"/>
                <a:ext cx="1112400" cy="1112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2" name="CuadroTexto 8"/>
              <p:cNvSpPr/>
              <p:nvPr/>
            </p:nvSpPr>
            <p:spPr>
              <a:xfrm>
                <a:off x="1594800" y="4317480"/>
                <a:ext cx="901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  <a:ea typeface="MS PGothic"/>
                  </a:rPr>
                  <a:t>NBM-MSC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CuadroTexto 12"/>
              <p:cNvSpPr/>
              <p:nvPr/>
            </p:nvSpPr>
            <p:spPr>
              <a:xfrm>
                <a:off x="3486600" y="4317480"/>
                <a:ext cx="849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  <a:ea typeface="MS PGothic"/>
                  </a:rPr>
                  <a:t>ALL-MSC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CuadroTexto 13"/>
              <p:cNvSpPr/>
              <p:nvPr/>
            </p:nvSpPr>
            <p:spPr>
              <a:xfrm>
                <a:off x="4292640" y="5639760"/>
                <a:ext cx="764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  <a:ea typeface="MS PGothic"/>
                  </a:rPr>
                  <a:t>VCAM-1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85" name="Conector recto de flecha 14"/>
              <p:cNvCxnSpPr/>
              <p:nvPr/>
            </p:nvCxnSpPr>
            <p:spPr>
              <a:xfrm flipV="1">
                <a:off x="1391760" y="4593240"/>
                <a:ext cx="1080" cy="922320"/>
              </a:xfrm>
              <a:prstGeom prst="straightConnector1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</p:cxnSp>
          <p:sp>
            <p:nvSpPr>
              <p:cNvPr id="86" name="CuadroTexto 15"/>
              <p:cNvSpPr/>
              <p:nvPr/>
            </p:nvSpPr>
            <p:spPr>
              <a:xfrm rot="16200000">
                <a:off x="1070280" y="4869720"/>
                <a:ext cx="4536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200" spc="-1" strike="noStrike">
                    <a:solidFill>
                      <a:srgbClr val="000000"/>
                    </a:solidFill>
                    <a:latin typeface="Times New Roman"/>
                    <a:ea typeface="MS PGothic"/>
                  </a:rPr>
                  <a:t>FSC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87" name="Picture 6" descr=""/>
              <p:cNvPicPr/>
              <p:nvPr/>
            </p:nvPicPr>
            <p:blipFill>
              <a:blip r:embed="rId9"/>
              <a:srcRect l="4580" t="5301" r="4139" b="32596"/>
              <a:stretch/>
            </p:blipFill>
            <p:spPr>
              <a:xfrm>
                <a:off x="3729600" y="4592520"/>
                <a:ext cx="1248480" cy="1056600"/>
              </a:xfrm>
              <a:prstGeom prst="rect">
                <a:avLst/>
              </a:prstGeom>
              <a:ln w="0">
                <a:noFill/>
              </a:ln>
            </p:spPr>
          </p:pic>
          <p:cxnSp>
            <p:nvCxnSpPr>
              <p:cNvPr id="88" name="Conector recto de flecha 13"/>
              <p:cNvCxnSpPr/>
              <p:nvPr/>
            </p:nvCxnSpPr>
            <p:spPr>
              <a:xfrm>
                <a:off x="1533960" y="5754960"/>
                <a:ext cx="2765160" cy="1080"/>
              </a:xfrm>
              <a:prstGeom prst="straightConnector1">
                <a:avLst/>
              </a:prstGeom>
              <a:ln w="19080">
                <a:solidFill>
                  <a:srgbClr val="000000"/>
                </a:solidFill>
                <a:miter/>
                <a:tailEnd len="med" type="triangle" w="med"/>
              </a:ln>
            </p:spPr>
          </p:cxn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12T03:08:14Z</dcterms:created>
  <dc:creator>PELAYO</dc:creator>
  <dc:description/>
  <dc:language>en-US</dc:language>
  <cp:lastModifiedBy>PELAYO</cp:lastModifiedBy>
  <dcterms:modified xsi:type="dcterms:W3CDTF">2016-12-12T03:46:36Z</dcterms:modified>
  <cp:revision>2</cp:revision>
  <dc:subject/>
  <dc:title>Diapositiva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2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2.PPT</vt:lpwstr>
  </property>
</Properties>
</file>